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1" r:id="rId2"/>
  </p:sldIdLst>
  <p:sldSz cx="6858000" cy="9906000" type="A4"/>
  <p:notesSz cx="6858000" cy="99456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佐和子 高村" initials="佐和子" lastIdx="8" clrIdx="0">
    <p:extLst>
      <p:ext uri="{19B8F6BF-5375-455C-9EA6-DF929625EA0E}">
        <p15:presenceInfo xmlns:p15="http://schemas.microsoft.com/office/powerpoint/2012/main" userId="a1e2fc2fc8c2c2e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127" autoAdjust="0"/>
    <p:restoredTop sz="83136" autoAdjust="0"/>
  </p:normalViewPr>
  <p:slideViewPr>
    <p:cSldViewPr snapToGrid="0">
      <p:cViewPr varScale="1">
        <p:scale>
          <a:sx n="42" d="100"/>
          <a:sy n="42" d="100"/>
        </p:scale>
        <p:origin x="2622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qpcr\20240509_CTL-CM_GAPDH-IGFBP1-PRL-WNT4-FOXO1-SCARA5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qpcr\20240509_CTL-CM_GAPDH-IGFBP1-PRL-WNT4-FOXO1-SCARA5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400" dirty="0">
                <a:solidFill>
                  <a:schemeClr val="tx1"/>
                </a:solidFill>
              </a:rPr>
              <a:t>PRL</a:t>
            </a:r>
            <a:endParaRPr lang="ja-JP" sz="140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45296296296296301"/>
          <c:y val="2.939814814814814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Sheet1!$N$68,Sheet1!$N$71)</c:f>
                <c:numCache>
                  <c:formatCode>General</c:formatCode>
                  <c:ptCount val="2"/>
                  <c:pt idx="0">
                    <c:v>0.12015582283653958</c:v>
                  </c:pt>
                  <c:pt idx="1">
                    <c:v>20.45887321652499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heet1!$E$66,Sheet1!$E$69)</c:f>
              <c:strCache>
                <c:ptCount val="2"/>
                <c:pt idx="0">
                  <c:v>CTL</c:v>
                </c:pt>
                <c:pt idx="1">
                  <c:v>8-br-cAMP/MPA</c:v>
                </c:pt>
              </c:strCache>
            </c:strRef>
          </c:cat>
          <c:val>
            <c:numRef>
              <c:f>(Sheet1!$M$66,Sheet1!$M$69)</c:f>
              <c:numCache>
                <c:formatCode>General</c:formatCode>
                <c:ptCount val="2"/>
                <c:pt idx="0">
                  <c:v>1</c:v>
                </c:pt>
                <c:pt idx="1">
                  <c:v>719.054496102564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581-4722-AD90-E9357F66D07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86716496"/>
        <c:axId val="1086725616"/>
      </c:barChart>
      <c:catAx>
        <c:axId val="10867164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086725616"/>
        <c:crosses val="autoZero"/>
        <c:auto val="1"/>
        <c:lblAlgn val="ctr"/>
        <c:lblOffset val="100"/>
        <c:noMultiLvlLbl val="0"/>
      </c:catAx>
      <c:valAx>
        <c:axId val="108672561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800" dirty="0">
                    <a:solidFill>
                      <a:schemeClr val="tx1"/>
                    </a:solidFill>
                  </a:rPr>
                  <a:t>Relative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086716496"/>
        <c:crosses val="autoZero"/>
        <c:crossBetween val="between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90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400" dirty="0"/>
              <a:t>IGFBP1</a:t>
            </a:r>
            <a:endParaRPr lang="ja-JP" sz="1400"/>
          </a:p>
        </c:rich>
      </c:tx>
      <c:layout>
        <c:manualLayout>
          <c:xMode val="edge"/>
          <c:yMode val="edge"/>
          <c:x val="0.438384238859574"/>
          <c:y val="2.351851851851851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32141153988553944"/>
          <c:y val="0.22983472222222226"/>
          <c:w val="0.61851579670241064"/>
          <c:h val="0.656443055555555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Sheet1!$N$36,Sheet1!$N$39)</c:f>
                <c:numCache>
                  <c:formatCode>General</c:formatCode>
                  <c:ptCount val="2"/>
                  <c:pt idx="0">
                    <c:v>0.1427344574777093</c:v>
                  </c:pt>
                  <c:pt idx="1">
                    <c:v>1411.853504221065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heet1!$E$34,Sheet1!$E$37)</c:f>
              <c:strCache>
                <c:ptCount val="2"/>
                <c:pt idx="0">
                  <c:v>CTL</c:v>
                </c:pt>
                <c:pt idx="1">
                  <c:v>8-br-cAMP/MPA</c:v>
                </c:pt>
              </c:strCache>
            </c:strRef>
          </c:cat>
          <c:val>
            <c:numRef>
              <c:f>(Sheet1!$M$34,Sheet1!$M$37)</c:f>
              <c:numCache>
                <c:formatCode>General</c:formatCode>
                <c:ptCount val="2"/>
                <c:pt idx="0">
                  <c:v>0.99999999999999989</c:v>
                </c:pt>
                <c:pt idx="1">
                  <c:v>20952.7799718363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4DF-4998-931C-9F68585933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86728016"/>
        <c:axId val="1086728496"/>
      </c:barChart>
      <c:catAx>
        <c:axId val="10867280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086728496"/>
        <c:crosses val="autoZero"/>
        <c:auto val="1"/>
        <c:lblAlgn val="ctr"/>
        <c:lblOffset val="100"/>
        <c:noMultiLvlLbl val="0"/>
      </c:catAx>
      <c:valAx>
        <c:axId val="108672849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800" dirty="0"/>
                  <a:t>Relative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algn="ctr" rtl="0">
                <a:defRPr sz="8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0867280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400" dirty="0"/>
              <a:t>WNT4</a:t>
            </a:r>
            <a:endParaRPr lang="ja-JP" sz="1400" dirty="0"/>
          </a:p>
        </c:rich>
      </c:tx>
      <c:layout>
        <c:manualLayout>
          <c:xMode val="edge"/>
          <c:yMode val="edge"/>
          <c:x val="0.46572175925925929"/>
          <c:y val="3.527777777777777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Sheet1!$N$14,Sheet1!$N$17)</c:f>
                <c:numCache>
                  <c:formatCode>General</c:formatCode>
                  <c:ptCount val="2"/>
                  <c:pt idx="0">
                    <c:v>8.9834625256474024E-2</c:v>
                  </c:pt>
                  <c:pt idx="1">
                    <c:v>16.55042330764243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heet1!$E$12,Sheet1!$E$15)</c:f>
              <c:strCache>
                <c:ptCount val="2"/>
                <c:pt idx="0">
                  <c:v>CTL</c:v>
                </c:pt>
                <c:pt idx="1">
                  <c:v>8-br-cAMP/MPA</c:v>
                </c:pt>
              </c:strCache>
            </c:strRef>
          </c:cat>
          <c:val>
            <c:numRef>
              <c:f>(Sheet1!$M$12,Sheet1!$M$15)</c:f>
              <c:numCache>
                <c:formatCode>General</c:formatCode>
                <c:ptCount val="2"/>
                <c:pt idx="0">
                  <c:v>1</c:v>
                </c:pt>
                <c:pt idx="1">
                  <c:v>419.464774847014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A56-4F91-8B4C-64751075499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67124464"/>
        <c:axId val="1067127344"/>
      </c:barChart>
      <c:catAx>
        <c:axId val="10671244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067127344"/>
        <c:crosses val="autoZero"/>
        <c:auto val="1"/>
        <c:lblAlgn val="ctr"/>
        <c:lblOffset val="100"/>
        <c:noMultiLvlLbl val="0"/>
      </c:catAx>
      <c:valAx>
        <c:axId val="106712734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800" dirty="0"/>
                  <a:t>Relative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067124464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9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71800" cy="499012"/>
          </a:xfrm>
          <a:prstGeom prst="rect">
            <a:avLst/>
          </a:prstGeom>
        </p:spPr>
        <p:txBody>
          <a:bodyPr vert="horz" lIns="91751" tIns="45875" rIns="91751" bIns="45875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4" y="0"/>
            <a:ext cx="2971800" cy="499012"/>
          </a:xfrm>
          <a:prstGeom prst="rect">
            <a:avLst/>
          </a:prstGeom>
        </p:spPr>
        <p:txBody>
          <a:bodyPr vert="horz" lIns="91751" tIns="45875" rIns="91751" bIns="45875" rtlCol="0"/>
          <a:lstStyle>
            <a:lvl1pPr algn="r">
              <a:defRPr sz="1200"/>
            </a:lvl1pPr>
          </a:lstStyle>
          <a:p>
            <a:fld id="{515787E3-5E9B-4BC8-9848-5F216E83DA6D}" type="datetimeFigureOut">
              <a:rPr kumimoji="1" lang="ja-JP" altLang="en-US" smtClean="0"/>
              <a:t>2025/1/1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66950" y="1244600"/>
            <a:ext cx="2324100" cy="33559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751" tIns="45875" rIns="91751" bIns="45875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786363"/>
            <a:ext cx="5486400" cy="3916114"/>
          </a:xfrm>
          <a:prstGeom prst="rect">
            <a:avLst/>
          </a:prstGeom>
        </p:spPr>
        <p:txBody>
          <a:bodyPr vert="horz" lIns="91751" tIns="45875" rIns="91751" bIns="45875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9446678"/>
            <a:ext cx="2971800" cy="499011"/>
          </a:xfrm>
          <a:prstGeom prst="rect">
            <a:avLst/>
          </a:prstGeom>
        </p:spPr>
        <p:txBody>
          <a:bodyPr vert="horz" lIns="91751" tIns="45875" rIns="91751" bIns="45875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4" y="9446678"/>
            <a:ext cx="2971800" cy="499011"/>
          </a:xfrm>
          <a:prstGeom prst="rect">
            <a:avLst/>
          </a:prstGeom>
        </p:spPr>
        <p:txBody>
          <a:bodyPr vert="horz" lIns="91751" tIns="45875" rIns="91751" bIns="45875" rtlCol="0" anchor="b"/>
          <a:lstStyle>
            <a:lvl1pPr algn="r">
              <a:defRPr sz="1200"/>
            </a:lvl1pPr>
          </a:lstStyle>
          <a:p>
            <a:fld id="{F1093EB7-316E-44A0-AAD8-BD94D29963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30463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266950" y="1244600"/>
            <a:ext cx="2324100" cy="3355975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17509">
              <a:defRPr/>
            </a:pPr>
            <a:r>
              <a:rPr kumimoji="1" lang="en-US" altLang="ja-JP" dirty="0"/>
              <a:t>Figure1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1093EB7-316E-44A0-AAD8-BD94D29963BE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91505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11A52A-6B9C-450C-A2AD-4D80171A3D8F}" type="datetimeFigureOut">
              <a:rPr kumimoji="1" lang="ja-JP" altLang="en-US" smtClean="0"/>
              <a:t>2025/1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D59032-7CCD-4B13-8A15-A0ABAB8FF9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41097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11A52A-6B9C-450C-A2AD-4D80171A3D8F}" type="datetimeFigureOut">
              <a:rPr kumimoji="1" lang="ja-JP" altLang="en-US" smtClean="0"/>
              <a:t>2025/1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D59032-7CCD-4B13-8A15-A0ABAB8FF9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70553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11A52A-6B9C-450C-A2AD-4D80171A3D8F}" type="datetimeFigureOut">
              <a:rPr kumimoji="1" lang="ja-JP" altLang="en-US" smtClean="0"/>
              <a:t>2025/1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D59032-7CCD-4B13-8A15-A0ABAB8FF9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62014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11A52A-6B9C-450C-A2AD-4D80171A3D8F}" type="datetimeFigureOut">
              <a:rPr kumimoji="1" lang="ja-JP" altLang="en-US" smtClean="0"/>
              <a:t>2025/1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D59032-7CCD-4B13-8A15-A0ABAB8FF9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91403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11A52A-6B9C-450C-A2AD-4D80171A3D8F}" type="datetimeFigureOut">
              <a:rPr kumimoji="1" lang="ja-JP" altLang="en-US" smtClean="0"/>
              <a:t>2025/1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D59032-7CCD-4B13-8A15-A0ABAB8FF9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19573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11A52A-6B9C-450C-A2AD-4D80171A3D8F}" type="datetimeFigureOut">
              <a:rPr kumimoji="1" lang="ja-JP" altLang="en-US" smtClean="0"/>
              <a:t>2025/1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D59032-7CCD-4B13-8A15-A0ABAB8FF9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21831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11A52A-6B9C-450C-A2AD-4D80171A3D8F}" type="datetimeFigureOut">
              <a:rPr kumimoji="1" lang="ja-JP" altLang="en-US" smtClean="0"/>
              <a:t>2025/1/1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D59032-7CCD-4B13-8A15-A0ABAB8FF9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25245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11A52A-6B9C-450C-A2AD-4D80171A3D8F}" type="datetimeFigureOut">
              <a:rPr kumimoji="1" lang="ja-JP" altLang="en-US" smtClean="0"/>
              <a:t>2025/1/1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D59032-7CCD-4B13-8A15-A0ABAB8FF9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05115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11A52A-6B9C-450C-A2AD-4D80171A3D8F}" type="datetimeFigureOut">
              <a:rPr kumimoji="1" lang="ja-JP" altLang="en-US" smtClean="0"/>
              <a:t>2025/1/1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D59032-7CCD-4B13-8A15-A0ABAB8FF9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76259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11A52A-6B9C-450C-A2AD-4D80171A3D8F}" type="datetimeFigureOut">
              <a:rPr kumimoji="1" lang="ja-JP" altLang="en-US" smtClean="0"/>
              <a:t>2025/1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D59032-7CCD-4B13-8A15-A0ABAB8FF9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59378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11A52A-6B9C-450C-A2AD-4D80171A3D8F}" type="datetimeFigureOut">
              <a:rPr kumimoji="1" lang="ja-JP" altLang="en-US" smtClean="0"/>
              <a:t>2025/1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D59032-7CCD-4B13-8A15-A0ABAB8FF9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76580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11A52A-6B9C-450C-A2AD-4D80171A3D8F}" type="datetimeFigureOut">
              <a:rPr kumimoji="1" lang="ja-JP" altLang="en-US" smtClean="0"/>
              <a:t>2025/1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D59032-7CCD-4B13-8A15-A0ABAB8FF9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68053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7" Type="http://schemas.openxmlformats.org/officeDocument/2006/relationships/image" Target="../media/image2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.JPG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6" name="グラフ 25">
            <a:extLst>
              <a:ext uri="{FF2B5EF4-FFF2-40B4-BE49-F238E27FC236}">
                <a16:creationId xmlns:a16="http://schemas.microsoft.com/office/drawing/2014/main" id="{A8F99727-03F2-7A5B-F795-79446B7DFBD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37947354"/>
              </p:ext>
            </p:extLst>
          </p:nvPr>
        </p:nvGraphicFramePr>
        <p:xfrm>
          <a:off x="2340000" y="3960000"/>
          <a:ext cx="21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A79D1168-3AF3-7730-763F-A19CF207B64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35322244"/>
              </p:ext>
            </p:extLst>
          </p:nvPr>
        </p:nvGraphicFramePr>
        <p:xfrm>
          <a:off x="180000" y="3960000"/>
          <a:ext cx="21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9" name="グラフ 28">
            <a:extLst>
              <a:ext uri="{FF2B5EF4-FFF2-40B4-BE49-F238E27FC236}">
                <a16:creationId xmlns:a16="http://schemas.microsoft.com/office/drawing/2014/main" id="{91617BB9-6AE3-3645-2251-962C57B2AA5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84136443"/>
              </p:ext>
            </p:extLst>
          </p:nvPr>
        </p:nvGraphicFramePr>
        <p:xfrm>
          <a:off x="4500000" y="3960000"/>
          <a:ext cx="21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pic>
        <p:nvPicPr>
          <p:cNvPr id="3" name="図 2">
            <a:extLst>
              <a:ext uri="{FF2B5EF4-FFF2-40B4-BE49-F238E27FC236}">
                <a16:creationId xmlns:a16="http://schemas.microsoft.com/office/drawing/2014/main" id="{8C0F7C26-D77C-0280-A1CB-53AB324787A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5644" y="1321383"/>
            <a:ext cx="3106967" cy="2330225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34D992A4-9232-82BD-DF6F-6B6F394E127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0828" y="1321384"/>
            <a:ext cx="3106967" cy="2330225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527F6E7-8F09-2502-DD93-10059B4D5A4C}"/>
              </a:ext>
            </a:extLst>
          </p:cNvPr>
          <p:cNvSpPr txBox="1"/>
          <p:nvPr/>
        </p:nvSpPr>
        <p:spPr>
          <a:xfrm>
            <a:off x="1549204" y="936273"/>
            <a:ext cx="9721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B31FFD7-693D-5831-8AA0-2E39292C844E}"/>
              </a:ext>
            </a:extLst>
          </p:cNvPr>
          <p:cNvSpPr txBox="1"/>
          <p:nvPr/>
        </p:nvSpPr>
        <p:spPr>
          <a:xfrm>
            <a:off x="4327735" y="952051"/>
            <a:ext cx="19621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8-br-cAMP/MPA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D8B2A27A-20CE-A840-7164-D452356ED9C4}"/>
              </a:ext>
            </a:extLst>
          </p:cNvPr>
          <p:cNvSpPr txBox="1"/>
          <p:nvPr/>
        </p:nvSpPr>
        <p:spPr>
          <a:xfrm>
            <a:off x="180000" y="952051"/>
            <a:ext cx="5176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6DC20026-C170-320C-4998-CC0F1C26772C}"/>
              </a:ext>
            </a:extLst>
          </p:cNvPr>
          <p:cNvGrpSpPr/>
          <p:nvPr/>
        </p:nvGrpSpPr>
        <p:grpSpPr>
          <a:xfrm>
            <a:off x="4518002" y="3959999"/>
            <a:ext cx="1638000" cy="785666"/>
            <a:chOff x="49181" y="3941482"/>
            <a:chExt cx="1638000" cy="785666"/>
          </a:xfrm>
        </p:grpSpPr>
        <p:cxnSp>
          <p:nvCxnSpPr>
            <p:cNvPr id="12" name="直線コネクタ 11">
              <a:extLst>
                <a:ext uri="{FF2B5EF4-FFF2-40B4-BE49-F238E27FC236}">
                  <a16:creationId xmlns:a16="http://schemas.microsoft.com/office/drawing/2014/main" id="{9FFE5AFD-AB2B-BB37-D43A-FE8A9BA4D8E9}"/>
                </a:ext>
              </a:extLst>
            </p:cNvPr>
            <p:cNvCxnSpPr>
              <a:cxnSpLocks/>
            </p:cNvCxnSpPr>
            <p:nvPr/>
          </p:nvCxnSpPr>
          <p:spPr>
            <a:xfrm>
              <a:off x="1021181" y="4445482"/>
              <a:ext cx="666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0DA7652F-1CE3-3A95-F4A5-3926901C4F84}"/>
                </a:ext>
              </a:extLst>
            </p:cNvPr>
            <p:cNvSpPr txBox="1"/>
            <p:nvPr/>
          </p:nvSpPr>
          <p:spPr>
            <a:xfrm>
              <a:off x="1219179" y="4265483"/>
              <a:ext cx="32982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ja-JP" altLang="en-US" sz="1200" b="1" dirty="0"/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A7D48063-7E5E-6F33-028B-DB39CE5838C5}"/>
                </a:ext>
              </a:extLst>
            </p:cNvPr>
            <p:cNvSpPr txBox="1"/>
            <p:nvPr/>
          </p:nvSpPr>
          <p:spPr>
            <a:xfrm>
              <a:off x="49181" y="3941482"/>
              <a:ext cx="5176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(e)</a:t>
              </a:r>
              <a:endParaRPr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6E2B2E48-5F95-822B-11C5-D4E6B5647B9D}"/>
              </a:ext>
            </a:extLst>
          </p:cNvPr>
          <p:cNvSpPr txBox="1"/>
          <p:nvPr/>
        </p:nvSpPr>
        <p:spPr>
          <a:xfrm>
            <a:off x="180000" y="3960000"/>
            <a:ext cx="512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A499210C-5242-B922-8B15-08C68CADE41E}"/>
              </a:ext>
            </a:extLst>
          </p:cNvPr>
          <p:cNvSpPr txBox="1"/>
          <p:nvPr/>
        </p:nvSpPr>
        <p:spPr>
          <a:xfrm>
            <a:off x="2340000" y="3960000"/>
            <a:ext cx="5176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F10A33B-2FF5-CB63-9753-BD9443E9D3EE}"/>
              </a:ext>
            </a:extLst>
          </p:cNvPr>
          <p:cNvSpPr txBox="1"/>
          <p:nvPr/>
        </p:nvSpPr>
        <p:spPr>
          <a:xfrm>
            <a:off x="3496730" y="936273"/>
            <a:ext cx="5176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6ACFD827-6432-31C8-2741-B4964980C13D}"/>
              </a:ext>
            </a:extLst>
          </p:cNvPr>
          <p:cNvCxnSpPr>
            <a:cxnSpLocks/>
          </p:cNvCxnSpPr>
          <p:nvPr/>
        </p:nvCxnSpPr>
        <p:spPr>
          <a:xfrm>
            <a:off x="2894399" y="3474721"/>
            <a:ext cx="2916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5AEE86C3-3A6E-0B8B-F05D-A06CCF1D8CFB}"/>
              </a:ext>
            </a:extLst>
          </p:cNvPr>
          <p:cNvCxnSpPr>
            <a:cxnSpLocks/>
          </p:cNvCxnSpPr>
          <p:nvPr/>
        </p:nvCxnSpPr>
        <p:spPr>
          <a:xfrm>
            <a:off x="6200042" y="3474721"/>
            <a:ext cx="2916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FA93E771-AF69-4C08-3ED3-D9A8696C7524}"/>
              </a:ext>
            </a:extLst>
          </p:cNvPr>
          <p:cNvCxnSpPr>
            <a:cxnSpLocks/>
          </p:cNvCxnSpPr>
          <p:nvPr/>
        </p:nvCxnSpPr>
        <p:spPr>
          <a:xfrm>
            <a:off x="1260000" y="4464000"/>
            <a:ext cx="612000" cy="57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43E0C294-5885-6C32-4E34-3AF2A5488D4C}"/>
              </a:ext>
            </a:extLst>
          </p:cNvPr>
          <p:cNvSpPr txBox="1"/>
          <p:nvPr/>
        </p:nvSpPr>
        <p:spPr>
          <a:xfrm>
            <a:off x="1440000" y="4284000"/>
            <a:ext cx="3298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ja-JP" altLang="en-US" sz="1200" b="1" dirty="0">
              <a:cs typeface="Arial" panose="020B0604020202020204" pitchFamily="34" charset="0"/>
            </a:endParaRPr>
          </a:p>
        </p:txBody>
      </p: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A779FDF2-94F3-45CC-CC75-B222A8CDF1F6}"/>
              </a:ext>
            </a:extLst>
          </p:cNvPr>
          <p:cNvCxnSpPr>
            <a:cxnSpLocks/>
          </p:cNvCxnSpPr>
          <p:nvPr/>
        </p:nvCxnSpPr>
        <p:spPr>
          <a:xfrm>
            <a:off x="3287644" y="4464000"/>
            <a:ext cx="72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9E2BF408-4B3F-1400-6CB5-EB32586EA666}"/>
              </a:ext>
            </a:extLst>
          </p:cNvPr>
          <p:cNvSpPr txBox="1"/>
          <p:nvPr/>
        </p:nvSpPr>
        <p:spPr>
          <a:xfrm>
            <a:off x="3528000" y="4284000"/>
            <a:ext cx="3298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ja-JP" altLang="en-US" sz="1200" b="1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0FF1D1E2-F97B-57B6-7E85-E77C34F1B8FC}"/>
              </a:ext>
            </a:extLst>
          </p:cNvPr>
          <p:cNvSpPr txBox="1"/>
          <p:nvPr/>
        </p:nvSpPr>
        <p:spPr>
          <a:xfrm>
            <a:off x="78723" y="6437134"/>
            <a:ext cx="1921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271139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6672</TotalTime>
  <Words>33</Words>
  <Application>Microsoft Office PowerPoint</Application>
  <PresentationFormat>A4 210 x 297 mm</PresentationFormat>
  <Paragraphs>18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哲 山口</dc:creator>
  <cp:lastModifiedBy>佐和子 高村</cp:lastModifiedBy>
  <cp:revision>42</cp:revision>
  <cp:lastPrinted>2025-01-10T07:12:32Z</cp:lastPrinted>
  <dcterms:created xsi:type="dcterms:W3CDTF">2024-05-10T04:22:11Z</dcterms:created>
  <dcterms:modified xsi:type="dcterms:W3CDTF">2025-01-17T06:18:20Z</dcterms:modified>
</cp:coreProperties>
</file>